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114800" cy="2743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A4CAA-8F36-4EB8-9D6E-7CE8CF409B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370224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06280" y="1586520"/>
            <a:ext cx="370224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7F5F2-03C3-4DFA-A9BD-98D0B955FC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103480" y="64116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06280" y="158652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103480" y="158652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0C6BE-5EBF-42CB-87F0-57EC3E0C0B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119196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58360" y="641160"/>
            <a:ext cx="119196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710080" y="641160"/>
            <a:ext cx="119196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06280" y="1586520"/>
            <a:ext cx="119196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58360" y="1586520"/>
            <a:ext cx="119196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710080" y="1586520"/>
            <a:ext cx="119196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5BE04-005E-4081-9168-E14D594743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06280" y="641160"/>
            <a:ext cx="3702240" cy="180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49"/>
              </a:spcBef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35C55-7027-47F8-B34E-0B192872BF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3702240" cy="18097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E8DCF-E32E-495D-9816-05E50DA096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1806480" cy="18097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103480" y="641160"/>
            <a:ext cx="1806480" cy="18097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14720-460F-472C-A4B4-30DAF5D468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CEE6D-BEB5-4F9E-84EB-E9FE2E6921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06280" y="109440"/>
            <a:ext cx="3702240" cy="2120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49"/>
              </a:spcBef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23C4B-9EF0-4047-AFCF-28DDB10F19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103480" y="641160"/>
            <a:ext cx="1806480" cy="18097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06280" y="158652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92E30-2682-4920-B331-24475EA54A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1806480" cy="18097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103480" y="64116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103480" y="158652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C31B7-D696-4F9D-B984-6723DCDE01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06280" y="64116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103480" y="641160"/>
            <a:ext cx="180648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06280" y="1586520"/>
            <a:ext cx="3702240" cy="8629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4B4D5-8543-4DB8-AC7B-A5ECD8DDFA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06280" y="109440"/>
            <a:ext cx="3702240" cy="4572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ctr">
            <a:noAutofit/>
          </a:bodyPr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06280" y="641160"/>
            <a:ext cx="3702240" cy="180972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rmAutofit/>
          </a:bodyPr>
          <a:p>
            <a:pPr marL="152280" indent="-1522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328680" indent="-125640">
              <a:spcBef>
                <a:spcPts val="349"/>
              </a:spcBef>
              <a:buClr>
                <a:srgbClr val="000000"/>
              </a:buClr>
              <a:buFont typeface="Arial"/>
              <a:buChar char="–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2" marL="506520" indent="-1018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3" marL="708120" indent="-100080">
              <a:spcBef>
                <a:spcPts val="349"/>
              </a:spcBef>
              <a:buClr>
                <a:srgbClr val="000000"/>
              </a:buClr>
              <a:buFont typeface="Arial"/>
              <a:buChar char="–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4" marL="911160" indent="-101520">
              <a:spcBef>
                <a:spcPts val="349"/>
              </a:spcBef>
              <a:buClr>
                <a:srgbClr val="000000"/>
              </a:buClr>
              <a:buFont typeface="Arial"/>
              <a:buChar char="»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5" marL="911160" indent="-101520">
              <a:spcBef>
                <a:spcPts val="349"/>
              </a:spcBef>
              <a:buClr>
                <a:srgbClr val="000000"/>
              </a:buClr>
              <a:buFont typeface="Arial"/>
              <a:buChar char="»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6" marL="911160" indent="-101520">
              <a:spcBef>
                <a:spcPts val="349"/>
              </a:spcBef>
              <a:buClr>
                <a:srgbClr val="000000"/>
              </a:buClr>
              <a:buFont typeface="Arial"/>
              <a:buChar char="»"/>
              <a:tabLst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06280" y="2496960"/>
            <a:ext cx="959040" cy="1908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Autofit/>
          </a:bodyPr>
          <a:lstStyle>
            <a:lvl1pPr indent="0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06520" y="2496960"/>
            <a:ext cx="1301760" cy="1908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Autofit/>
          </a:bodyPr>
          <a:lstStyle>
            <a:lvl1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949480" y="2496960"/>
            <a:ext cx="959040" cy="190800"/>
          </a:xfrm>
          <a:prstGeom prst="rect">
            <a:avLst/>
          </a:prstGeom>
          <a:noFill/>
          <a:ln w="0">
            <a:noFill/>
          </a:ln>
        </p:spPr>
        <p:txBody>
          <a:bodyPr lIns="40320" rIns="40320" tIns="20160" bIns="20160" anchor="t">
            <a:noAutofit/>
          </a:bodyPr>
          <a:lstStyle>
            <a:lvl1pPr indent="0" algn="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fld id="{C93C31AE-5E8D-452F-9A16-7F45802FB95C}" type="slidenum">
              <a:rPr b="0" lang="en-US" sz="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-6480"/>
          <a:ext cx="4038480" cy="24829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-6480"/>
                    <a:ext cx="4038480" cy="248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289080" y="2446200"/>
            <a:ext cx="183960" cy="21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6680" y="2284560"/>
            <a:ext cx="4082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upplementary Figure 1.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calability of fREDUCE.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he performance of fREDUCE on yeast ChIP-chip experiment REB1_YPD for variou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04640"/>
                <a:tab algn="l" pos="809640"/>
                <a:tab algn="l" pos="1214280"/>
                <a:tab algn="l" pos="1619280"/>
                <a:tab algn="l" pos="2023920"/>
                <a:tab algn="l" pos="2428920"/>
                <a:tab algn="l" pos="2833560"/>
                <a:tab algn="l" pos="3238560"/>
                <a:tab algn="l" pos="3643200"/>
                <a:tab algn="l" pos="4048200"/>
                <a:tab algn="l" pos="4452840"/>
                <a:tab algn="l" pos="4857840"/>
                <a:tab algn="l" pos="5262480"/>
                <a:tab algn="l" pos="5667480"/>
                <a:tab algn="l" pos="6072120"/>
                <a:tab algn="l" pos="6477120"/>
                <a:tab algn="l" pos="6881760"/>
                <a:tab algn="l" pos="7286760"/>
                <a:tab algn="l" pos="7691400"/>
                <a:tab algn="l" pos="8096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tif lengths and numbers of degeneracies.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14T23:48:23Z</dcterms:created>
  <dc:creator>Randy Wu</dc:creator>
  <dc:description/>
  <dc:language>en-US</dc:language>
  <cp:lastModifiedBy>RandyWu</cp:lastModifiedBy>
  <dcterms:modified xsi:type="dcterms:W3CDTF">2007-10-11T02:44:04Z</dcterms:modified>
  <cp:revision>3</cp:revision>
  <dc:subject/>
  <dc:title>Slide 1</dc:title>
</cp:coreProperties>
</file>